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433" r:id="rId2"/>
  </p:sldIdLst>
  <p:sldSz cx="6858000" cy="9906000" type="A4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度样式 2 - 强调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98"/>
    <p:restoredTop sz="94694"/>
  </p:normalViewPr>
  <p:slideViewPr>
    <p:cSldViewPr>
      <p:cViewPr varScale="1">
        <p:scale>
          <a:sx n="61" d="100"/>
          <a:sy n="61" d="100"/>
        </p:scale>
        <p:origin x="3072" y="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8B756-ECB1-4A80-91ED-52F8A9CA94E5}" type="datetimeFigureOut">
              <a:rPr lang="zh-CN" altLang="en-US" smtClean="0"/>
              <a:pPr/>
              <a:t>2019-9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D51FEB09-DCF4-6047-B8FD-396E2A0799AC}"/>
              </a:ext>
            </a:extLst>
          </p:cNvPr>
          <p:cNvSpPr/>
          <p:nvPr/>
        </p:nvSpPr>
        <p:spPr>
          <a:xfrm>
            <a:off x="87474" y="7833320"/>
            <a:ext cx="668305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 comparison of indels identified in the CASPMI project (pink) with those present in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dbSN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(olive green), 1KGP (gray), 1KGP EAS (green), and the 90 Han Chinese genome study (90 Han, blue). 1KGP, 1000 Genomes Project; 1KGP EAS, East Asians included in 1KGP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5CC0F943-216D-3547-9886-2E5FF1D9E5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288704"/>
            <a:ext cx="6858000" cy="33410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5451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9</TotalTime>
  <Words>59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A</cp:lastModifiedBy>
  <cp:revision>212</cp:revision>
  <dcterms:created xsi:type="dcterms:W3CDTF">2017-07-18T13:30:22Z</dcterms:created>
  <dcterms:modified xsi:type="dcterms:W3CDTF">2019-08-31T16:57:51Z</dcterms:modified>
</cp:coreProperties>
</file>